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59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87"/>
  </p:normalViewPr>
  <p:slideViewPr>
    <p:cSldViewPr snapToGrid="0" snapToObjects="1">
      <p:cViewPr>
        <p:scale>
          <a:sx n="133" d="100"/>
          <a:sy n="133" d="100"/>
        </p:scale>
        <p:origin x="1992" y="-2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MX"/>
              <a:t>Haz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9474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00794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30607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7032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46596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06940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47756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91812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10410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14175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MX"/>
              <a:t>Haz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43778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2A7E7-BACA-144A-BE90-91BF9CA5AD13}" type="datetimeFigureOut">
              <a:rPr lang="es-MX" smtClean="0"/>
              <a:t>08/04/20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C3E1C-F5BE-474E-8B90-0DD98C3A3F0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59069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Documento_de_Microsoft_Word.doc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015B9C9-5051-7143-AD0E-26BDA6F6E8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MX"/>
          </a:p>
        </p:txBody>
      </p:sp>
      <p:pic>
        <p:nvPicPr>
          <p:cNvPr id="4097" name="Imagen 1" descr="59660707_895037330888503_1565708058351370240_n (1)">
            <a:extLst>
              <a:ext uri="{FF2B5EF4-FFF2-40B4-BE49-F238E27FC236}">
                <a16:creationId xmlns:a16="http://schemas.microsoft.com/office/drawing/2014/main" id="{998FDE9C-3768-EC40-AE5F-8DF506179A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86" y="457200"/>
            <a:ext cx="5613400" cy="64890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5A895FC0-B4CC-AA4B-8CF2-E029D7992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91" y="7019716"/>
            <a:ext cx="6777817" cy="144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Map of concentration of arsenic in the water of the Comarca </a:t>
            </a:r>
            <a:r>
              <a:rPr kumimoji="0" lang="en-US" altLang="es-MX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gunera</a:t>
            </a:r>
            <a:endParaRPr kumimoji="0" lang="en-US" altLang="es-MX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: </a:t>
            </a:r>
            <a:r>
              <a:rPr kumimoji="0" lang="en-US" altLang="es-MX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 of As water</a:t>
            </a: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B: </a:t>
            </a:r>
            <a:r>
              <a:rPr kumimoji="0" lang="en-US" altLang="es-MX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ter from the goat trough</a:t>
            </a:r>
            <a:endParaRPr kumimoji="0" lang="en-US" altLang="es-MX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SUPPLEMENTARY MATERIAL. FILE 1</a:t>
            </a:r>
            <a:endParaRPr kumimoji="0" lang="en-US" altLang="es-MX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The map shows the geographical distribution of the towns and municipalities that were sampled in the study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The location of the main municipalities of the </a:t>
            </a:r>
            <a:r>
              <a:rPr kumimoji="0" lang="en-US" altLang="es-MX" sz="1000" b="0" i="0" u="none" strike="noStrike" cap="none" normalizeH="0" baseline="0" dirty="0" err="1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Lagunera</a:t>
            </a: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 Region is specified in order to illustrate the distances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 between the villages and how the problem of </a:t>
            </a:r>
            <a:r>
              <a:rPr kumimoji="0" lang="en-US" altLang="es-MX" sz="1000" b="0" i="0" u="none" strike="noStrike" cap="none" normalizeH="0" baseline="0" dirty="0" err="1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hydroarsenicism</a:t>
            </a: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 is present in a large part of our region.</a:t>
            </a:r>
            <a:endParaRPr kumimoji="0" lang="en-US" altLang="es-MX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On the other hand, a table is added that shows the municipalities the origin of the water contaminated with arsenic,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MX" sz="10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 (Cuerpo en alfa"/>
              </a:rPr>
              <a:t>pH, as well as the electrical conductivity. Likewise, the exact geographical location of the mentioned municipality is described.</a:t>
            </a:r>
            <a:r>
              <a:rPr kumimoji="0" lang="en-US" altLang="es-MX" sz="1200" b="0" i="0" u="none" strike="noStrike" cap="none" normalizeH="0" baseline="0" dirty="0">
                <a:ln>
                  <a:noFill/>
                </a:ln>
                <a:solidFill>
                  <a:srgbClr val="1D2228"/>
                </a:solidFill>
                <a:effectLst/>
                <a:latin typeface="Helvetica Neue" panose="0200050300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US" altLang="es-MX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5440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lementos multimedia en línea 3" descr="Supplementary file 2. mp4.mp4">
            <a:hlinkClick r:id="" action="ppaction://media"/>
            <a:extLst>
              <a:ext uri="{FF2B5EF4-FFF2-40B4-BE49-F238E27FC236}">
                <a16:creationId xmlns:a16="http://schemas.microsoft.com/office/drawing/2014/main" id="{300E4F17-5B5D-AE49-B50A-C6E462F9E0E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1488" y="3633788"/>
            <a:ext cx="5915025" cy="3400425"/>
          </a:xfrm>
        </p:spPr>
      </p:pic>
    </p:spTree>
    <p:extLst>
      <p:ext uri="{BB962C8B-B14F-4D97-AF65-F5344CB8AC3E}">
        <p14:creationId xmlns:p14="http://schemas.microsoft.com/office/powerpoint/2010/main" val="38612128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70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BF8BC99E-2785-9D41-A779-29461A87648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2300" y="1663700"/>
          <a:ext cx="5613400" cy="581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Documento" r:id="rId3" imgW="5613400" imgH="5816600" progId="Word.Document.12">
                  <p:embed/>
                </p:oleObj>
              </mc:Choice>
              <mc:Fallback>
                <p:oleObj name="Documento" r:id="rId3" imgW="5613400" imgH="5816600" progId="Word.Document.12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BF8BC99E-2785-9D41-A779-29461A8764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2300" y="1663700"/>
                        <a:ext cx="5613400" cy="581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483875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29</Words>
  <Application>Microsoft Macintosh PowerPoint</Application>
  <PresentationFormat>Carta (216 x 279 mm)</PresentationFormat>
  <Paragraphs>8</Paragraphs>
  <Slides>3</Slides>
  <Notes>0</Notes>
  <HiddenSlides>0</HiddenSlides>
  <MMClips>1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Helvetica Neue</vt:lpstr>
      <vt:lpstr>Times New Roman</vt:lpstr>
      <vt:lpstr>Tema de Office</vt:lpstr>
      <vt:lpstr>Documento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Moran Martinez</dc:creator>
  <cp:lastModifiedBy>Javier Moran Martinez</cp:lastModifiedBy>
  <cp:revision>3</cp:revision>
  <dcterms:created xsi:type="dcterms:W3CDTF">2020-03-22T23:46:15Z</dcterms:created>
  <dcterms:modified xsi:type="dcterms:W3CDTF">2020-04-09T02:25:34Z</dcterms:modified>
</cp:coreProperties>
</file>